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672" userDrawn="1">
          <p15:clr>
            <a:srgbClr val="A4A3A4"/>
          </p15:clr>
        </p15:guide>
        <p15:guide id="2" pos="48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68" d="100"/>
          <a:sy n="68" d="100"/>
        </p:scale>
        <p:origin x="792" y="60"/>
      </p:cViewPr>
      <p:guideLst>
        <p:guide orient="horz" pos="3672"/>
        <p:guide pos="482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53EB-751E-44CB-BEF1-6BDA63B5E85D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9A6FD-1F88-4314-B461-C72737647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81190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53EB-751E-44CB-BEF1-6BDA63B5E85D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9A6FD-1F88-4314-B461-C72737647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49733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53EB-751E-44CB-BEF1-6BDA63B5E85D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9A6FD-1F88-4314-B461-C72737647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01006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53EB-751E-44CB-BEF1-6BDA63B5E85D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9A6FD-1F88-4314-B461-C72737647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69794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53EB-751E-44CB-BEF1-6BDA63B5E85D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9A6FD-1F88-4314-B461-C72737647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9327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53EB-751E-44CB-BEF1-6BDA63B5E85D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9A6FD-1F88-4314-B461-C72737647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09336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53EB-751E-44CB-BEF1-6BDA63B5E85D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9A6FD-1F88-4314-B461-C72737647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97176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53EB-751E-44CB-BEF1-6BDA63B5E85D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9A6FD-1F88-4314-B461-C72737647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90846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53EB-751E-44CB-BEF1-6BDA63B5E85D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9A6FD-1F88-4314-B461-C72737647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40653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53EB-751E-44CB-BEF1-6BDA63B5E85D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9A6FD-1F88-4314-B461-C72737647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8744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53EB-751E-44CB-BEF1-6BDA63B5E85D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9A6FD-1F88-4314-B461-C72737647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33019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D653EB-751E-44CB-BEF1-6BDA63B5E85D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69A6FD-1F88-4314-B461-C72737647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10066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00188" y="5456575"/>
            <a:ext cx="10444163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2 Fig.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B-cell epitope prediction of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lagellar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hook-associated protein (A: Linear, B: Beta-turn, C: Flexibility, D: Surface Accessibility, E: Antigenicity, F: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ydrophilicity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For each graph, X-axis and Y-axis represent the position and score. Residues that fall above the threshold value are shown in yellow color while the highest peak in yellow color identifies most favored position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Picture 4" descr="C:\Users\User\Desktop\Hasan_Vibrio\fwdallfiguresmahmudulhasan\Supplementary Figure 2.jpg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14700" y="0"/>
            <a:ext cx="6109970" cy="5456575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534274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6</TotalTime>
  <Words>73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Sathish</cp:lastModifiedBy>
  <cp:revision>19</cp:revision>
  <dcterms:created xsi:type="dcterms:W3CDTF">2020-03-31T14:28:06Z</dcterms:created>
  <dcterms:modified xsi:type="dcterms:W3CDTF">2020-07-30T10:13:06Z</dcterms:modified>
</cp:coreProperties>
</file>